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60" r:id="rId4"/>
    <p:sldId id="258" r:id="rId5"/>
    <p:sldId id="259" r:id="rId6"/>
    <p:sldId id="261" r:id="rId7"/>
  </p:sldIdLst>
  <p:sldSz cx="12192000" cy="6858000"/>
  <p:notesSz cx="6858000" cy="9144000"/>
  <p:defaultTextStyle>
    <a:defPPr>
      <a:defRPr lang="sv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4" autoAdjust="0"/>
    <p:restoredTop sz="94660"/>
  </p:normalViewPr>
  <p:slideViewPr>
    <p:cSldViewPr snapToGrid="0" showGuides="1">
      <p:cViewPr varScale="1">
        <p:scale>
          <a:sx n="88" d="100"/>
          <a:sy n="88" d="100"/>
        </p:scale>
        <p:origin x="576" y="9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Rubrikbi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Underrubrik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sv-SE" smtClean="0"/>
              <a:t>Klicka här för att ändra format på underrubrik i bakgrunden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70C368-C2F1-43E0-A190-6A4B67B437DA}" type="datetimeFigureOut">
              <a:rPr lang="sv-SE" smtClean="0"/>
              <a:t>2016-07-05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59A7AC-B00D-4335-812D-D49BECDC2C76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7103307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Rubrik och lodrät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lodrät tex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70C368-C2F1-43E0-A190-6A4B67B437DA}" type="datetimeFigureOut">
              <a:rPr lang="sv-SE" smtClean="0"/>
              <a:t>2016-07-05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59A7AC-B00D-4335-812D-D49BECDC2C76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2960620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ät rubrik och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ät rubrik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lodrät text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70C368-C2F1-43E0-A190-6A4B67B437DA}" type="datetimeFigureOut">
              <a:rPr lang="sv-SE" smtClean="0"/>
              <a:t>2016-07-05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59A7AC-B00D-4335-812D-D49BECDC2C76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2572244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Rubrik och innehål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innehåll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70C368-C2F1-43E0-A190-6A4B67B437DA}" type="datetimeFigureOut">
              <a:rPr lang="sv-SE" smtClean="0"/>
              <a:t>2016-07-05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59A7AC-B00D-4335-812D-D49BECDC2C76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7923781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vsnitts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70C368-C2F1-43E0-A190-6A4B67B437DA}" type="datetimeFigureOut">
              <a:rPr lang="sv-SE" smtClean="0"/>
              <a:t>2016-07-05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59A7AC-B00D-4335-812D-D49BECDC2C76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6988635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vå innehållsdela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innehåll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innehåll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70C368-C2F1-43E0-A190-6A4B67B437DA}" type="datetimeFigureOut">
              <a:rPr lang="sv-SE" smtClean="0"/>
              <a:t>2016-07-05</a:t>
            </a:fld>
            <a:endParaRPr lang="sv-SE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59A7AC-B00D-4335-812D-D49BECDC2C76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2856913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Jämförels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4" name="Platshållare för innehåll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5" name="Platshållare för text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6" name="Platshållare för innehåll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7" name="Platshållare för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70C368-C2F1-43E0-A190-6A4B67B437DA}" type="datetimeFigureOut">
              <a:rPr lang="sv-SE" smtClean="0"/>
              <a:t>2016-07-05</a:t>
            </a:fld>
            <a:endParaRPr lang="sv-SE"/>
          </a:p>
        </p:txBody>
      </p:sp>
      <p:sp>
        <p:nvSpPr>
          <p:cNvPr id="8" name="Platshållare för sidfo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9" name="Platshållare för bild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59A7AC-B00D-4335-812D-D49BECDC2C76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2652859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Endast 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70C368-C2F1-43E0-A190-6A4B67B437DA}" type="datetimeFigureOut">
              <a:rPr lang="sv-SE" smtClean="0"/>
              <a:t>2016-07-05</a:t>
            </a:fld>
            <a:endParaRPr lang="sv-SE"/>
          </a:p>
        </p:txBody>
      </p:sp>
      <p:sp>
        <p:nvSpPr>
          <p:cNvPr id="4" name="Platshållare för sidfo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5" name="Platshållare för bild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59A7AC-B00D-4335-812D-D49BECDC2C76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8679145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70C368-C2F1-43E0-A190-6A4B67B437DA}" type="datetimeFigureOut">
              <a:rPr lang="sv-SE" smtClean="0"/>
              <a:t>2016-07-05</a:t>
            </a:fld>
            <a:endParaRPr lang="sv-SE"/>
          </a:p>
        </p:txBody>
      </p:sp>
      <p:sp>
        <p:nvSpPr>
          <p:cNvPr id="3" name="Platshållare för sidfo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Platshållare för bild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59A7AC-B00D-4335-812D-D49BECDC2C76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1615818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nehåll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innehåll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text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70C368-C2F1-43E0-A190-6A4B67B437DA}" type="datetimeFigureOut">
              <a:rPr lang="sv-SE" smtClean="0"/>
              <a:t>2016-07-05</a:t>
            </a:fld>
            <a:endParaRPr lang="sv-SE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59A7AC-B00D-4335-812D-D49BECDC2C76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3428734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bild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sv-SE"/>
          </a:p>
        </p:txBody>
      </p:sp>
      <p:sp>
        <p:nvSpPr>
          <p:cNvPr id="4" name="Platshållare för text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70C368-C2F1-43E0-A190-6A4B67B437DA}" type="datetimeFigureOut">
              <a:rPr lang="sv-SE" smtClean="0"/>
              <a:t>2016-07-05</a:t>
            </a:fld>
            <a:endParaRPr lang="sv-SE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59A7AC-B00D-4335-812D-D49BECDC2C76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4108467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rubrik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70C368-C2F1-43E0-A190-6A4B67B437DA}" type="datetimeFigureOut">
              <a:rPr lang="sv-SE" smtClean="0"/>
              <a:t>2016-07-05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59A7AC-B00D-4335-812D-D49BECDC2C76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7900502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sv-SE" dirty="0" smtClean="0"/>
              <a:t>Multimedia </a:t>
            </a:r>
            <a:r>
              <a:rPr lang="sv-SE" smtClean="0"/>
              <a:t>appendix </a:t>
            </a:r>
            <a:r>
              <a:rPr lang="sv-SE" smtClean="0"/>
              <a:t>1</a:t>
            </a:r>
            <a:endParaRPr lang="sv-SE" dirty="0"/>
          </a:p>
        </p:txBody>
      </p:sp>
      <p:sp>
        <p:nvSpPr>
          <p:cNvPr id="3" name="Underrubrik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US" dirty="0" smtClean="0"/>
              <a:t>Screenshots of the treatment platform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985309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Screenshot of the public web-site</a:t>
            </a:r>
            <a:endParaRPr lang="en-US" dirty="0"/>
          </a:p>
        </p:txBody>
      </p:sp>
      <p:pic>
        <p:nvPicPr>
          <p:cNvPr id="4" name="Platshållare för innehåll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95149" y="1586138"/>
            <a:ext cx="7405064" cy="5195661"/>
          </a:xfrm>
        </p:spPr>
      </p:pic>
    </p:spTree>
    <p:extLst>
      <p:ext uri="{BB962C8B-B14F-4D97-AF65-F5344CB8AC3E}">
        <p14:creationId xmlns:p14="http://schemas.microsoft.com/office/powerpoint/2010/main" val="141665955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Screenshot of the start-page (logged in) </a:t>
            </a:r>
            <a:endParaRPr lang="sv-SE" dirty="0"/>
          </a:p>
        </p:txBody>
      </p:sp>
      <p:pic>
        <p:nvPicPr>
          <p:cNvPr id="4" name="Platshållare för innehåll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13582" y="1509939"/>
            <a:ext cx="8875173" cy="5065032"/>
          </a:xfrm>
        </p:spPr>
      </p:pic>
    </p:spTree>
    <p:extLst>
      <p:ext uri="{BB962C8B-B14F-4D97-AF65-F5344CB8AC3E}">
        <p14:creationId xmlns:p14="http://schemas.microsoft.com/office/powerpoint/2010/main" val="341857673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Screenshot of the module headings</a:t>
            </a:r>
            <a:endParaRPr lang="sv-SE" dirty="0"/>
          </a:p>
        </p:txBody>
      </p:sp>
      <p:pic>
        <p:nvPicPr>
          <p:cNvPr id="5" name="Platshållare för innehåll 4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94836" y="1910264"/>
            <a:ext cx="8802328" cy="4182059"/>
          </a:xfrm>
        </p:spPr>
      </p:pic>
    </p:spTree>
    <p:extLst>
      <p:ext uri="{BB962C8B-B14F-4D97-AF65-F5344CB8AC3E}">
        <p14:creationId xmlns:p14="http://schemas.microsoft.com/office/powerpoint/2010/main" val="15571562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Screenshot of part of text in module </a:t>
            </a:r>
            <a:endParaRPr lang="sv-SE" dirty="0"/>
          </a:p>
        </p:txBody>
      </p:sp>
      <p:pic>
        <p:nvPicPr>
          <p:cNvPr id="4" name="Platshållare för innehåll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16550" y="1270453"/>
            <a:ext cx="5358899" cy="5587547"/>
          </a:xfrm>
        </p:spPr>
      </p:pic>
    </p:spTree>
    <p:extLst>
      <p:ext uri="{BB962C8B-B14F-4D97-AF65-F5344CB8AC3E}">
        <p14:creationId xmlns:p14="http://schemas.microsoft.com/office/powerpoint/2010/main" val="383696715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Screenshot, example of homework assignment </a:t>
            </a:r>
            <a:endParaRPr lang="en-US" dirty="0"/>
          </a:p>
        </p:txBody>
      </p:sp>
      <p:pic>
        <p:nvPicPr>
          <p:cNvPr id="4" name="Platshållare för innehåll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73240" y="1564366"/>
            <a:ext cx="5805446" cy="5165691"/>
          </a:xfrm>
        </p:spPr>
      </p:pic>
    </p:spTree>
    <p:extLst>
      <p:ext uri="{BB962C8B-B14F-4D97-AF65-F5344CB8AC3E}">
        <p14:creationId xmlns:p14="http://schemas.microsoft.com/office/powerpoint/2010/main" val="14566313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9</TotalTime>
  <Words>39</Words>
  <Application>Microsoft Office PowerPoint</Application>
  <PresentationFormat>Bredbild</PresentationFormat>
  <Paragraphs>7</Paragraphs>
  <Slides>6</Slides>
  <Notes>0</Notes>
  <HiddenSlides>0</HiddenSlides>
  <MMClips>0</MMClips>
  <ScaleCrop>false</ScaleCrop>
  <HeadingPairs>
    <vt:vector size="6" baseType="variant">
      <vt:variant>
        <vt:lpstr>Använt teckensnitt</vt:lpstr>
      </vt:variant>
      <vt:variant>
        <vt:i4>3</vt:i4>
      </vt:variant>
      <vt:variant>
        <vt:lpstr>Tema</vt:lpstr>
      </vt:variant>
      <vt:variant>
        <vt:i4>1</vt:i4>
      </vt:variant>
      <vt:variant>
        <vt:lpstr>Bildrubriker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-tema</vt:lpstr>
      <vt:lpstr>Multimedia appendix 1</vt:lpstr>
      <vt:lpstr>Screenshot of the public web-site</vt:lpstr>
      <vt:lpstr>Screenshot of the start-page (logged in) </vt:lpstr>
      <vt:lpstr>Screenshot of the module headings</vt:lpstr>
      <vt:lpstr>Screenshot of part of text in module </vt:lpstr>
      <vt:lpstr>Screenshot, example of homework assignment </vt:lpstr>
    </vt:vector>
  </TitlesOfParts>
  <Company>Linköpings universitet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ultimedia appendix 2</dc:title>
  <dc:creator>Johan Lundgren</dc:creator>
  <cp:lastModifiedBy>Johan Lundgren</cp:lastModifiedBy>
  <cp:revision>5</cp:revision>
  <dcterms:created xsi:type="dcterms:W3CDTF">2016-01-17T22:06:24Z</dcterms:created>
  <dcterms:modified xsi:type="dcterms:W3CDTF">2016-07-05T18:35:13Z</dcterms:modified>
</cp:coreProperties>
</file>